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l-PL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l-PL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DAA64E0-D6B6-49B4-8DE7-6711D16F57DE}" type="slidenum">
              <a:rPr b="0" lang="pl-PL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7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pl-PL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Symbol zastępczy numeru slajdu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83A0C2E-6DBD-437E-A44C-B021C0C4A37E}" type="slidenum">
              <a:rPr b="0" lang="pl-PL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7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Calibri"/>
              </a:rPr>
              <a:t>fig suppl ESM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Symbol zastępczy numeru slajdu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647B298-8BA5-4A2A-940D-855F54CE3EC3}" type="slidenum">
              <a:rPr b="0" lang="pl-PL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3A84DB-2D1F-4A0C-A8CF-0C933E59C33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2C971B-CDE9-45FE-82D3-C52FFC8E108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C05AA9-56C8-49F8-9E55-68D87C9C7AB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8DA399-7314-4690-B7D6-7C11989A917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6D166F-8A6B-4302-A48B-7C24FDECFF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2A8A55-809E-43BC-BE10-B056F54A5BF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303DD0-D069-464D-B4AA-509EFF94062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17345A-0C80-47C9-A648-7ED58D6F7ED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B96FA7-639C-4D8C-B170-77903D7F9D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A57F60-D8A9-4E12-84C8-154039A117F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D78888-1D08-43F8-8B20-83EB48661E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D4C3D9-B1C4-45A5-83BD-8DA79C7623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l-P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l-P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0CD79C5-187F-4F08-9E60-24D34D7C0E0B}" type="slidenum">
              <a:rPr b="0" lang="pl-PL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hyperlink" Target="mailto:iwona.szarejko@us.edu.pl" TargetMode="External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slideLayout" Target="../slideLayouts/slideLayout1.xml"/><Relationship Id="rId7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1"/>
          <p:cNvSpPr/>
          <p:nvPr/>
        </p:nvSpPr>
        <p:spPr>
          <a:xfrm>
            <a:off x="233280" y="1205280"/>
            <a:ext cx="8750520" cy="2770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Morphological, genetic and molecular characteristics of barley root  hair mutan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Journal of Applied Genetic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eata Chmielewska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, Agnieszka Janiak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, Jagna Karcz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, Justyna Guzy-Wrobelska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, Brian P. Forster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3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, Malgorzata Nawrot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, Anna Rusek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, Paulina Smyda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, Piotr Kędziorski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, Miroslaw Małuszynski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and Iwona Szarejko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Department of Genetics, University of Silesia, Jagiellońska 28, 40-032 Katowice, Poland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Scanning Electron Microscopy Laboratory, University of Silesia, Jagiellońska 28, 40-032 Katowice, Poland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3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The James Hutton Institute, Invergowrie, Dundee DD2 5DA, Scotland, UK. Current address: Plant Breeding and Genetics Laboratory, Joint FAO/IAEA Division, IAEA Laboratories, A-2444 Seibersdorf, Austri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corresponding author: </a:t>
            </a:r>
            <a:r>
              <a:rPr b="0" lang="en-US" sz="1200" spc="-1" strike="noStrike" u="sng">
                <a:solidFill>
                  <a:srgbClr val="0000ff"/>
                </a:solidFill>
                <a:uFillTx/>
                <a:latin typeface="Arial"/>
                <a:ea typeface="Times New Roman"/>
                <a:hlinkClick r:id="rId1"/>
              </a:rPr>
              <a:t>iwona.szarejko@us.edu.pl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, tel: +48 3220095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1200"/>
            </a:b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Łącznik prosty 16"/>
          <p:cNvSpPr/>
          <p:nvPr/>
        </p:nvSpPr>
        <p:spPr>
          <a:xfrm flipV="1">
            <a:off x="2755800" y="816120"/>
            <a:ext cx="614520" cy="1055520"/>
          </a:xfrm>
          <a:prstGeom prst="line">
            <a:avLst/>
          </a:prstGeom>
          <a:ln w="2844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Łącznik prosty 18"/>
          <p:cNvSpPr/>
          <p:nvPr/>
        </p:nvSpPr>
        <p:spPr>
          <a:xfrm flipV="1">
            <a:off x="2933640" y="1820880"/>
            <a:ext cx="979560" cy="412560"/>
          </a:xfrm>
          <a:prstGeom prst="line">
            <a:avLst/>
          </a:prstGeom>
          <a:ln w="2844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1" name="Grupa 22"/>
          <p:cNvGrpSpPr/>
          <p:nvPr/>
        </p:nvGrpSpPr>
        <p:grpSpPr>
          <a:xfrm>
            <a:off x="3394080" y="593640"/>
            <a:ext cx="1101600" cy="1301760"/>
            <a:chOff x="3394080" y="593640"/>
            <a:chExt cx="1101600" cy="1301760"/>
          </a:xfrm>
        </p:grpSpPr>
        <p:pic>
          <p:nvPicPr>
            <p:cNvPr id="52" name="Obraz 12" descr="DSC01734.JPG"/>
            <p:cNvPicPr/>
            <p:nvPr/>
          </p:nvPicPr>
          <p:blipFill>
            <a:blip r:embed="rId1"/>
            <a:srcRect l="0" t="8811" r="2602" b="5014"/>
            <a:stretch/>
          </p:blipFill>
          <p:spPr>
            <a:xfrm>
              <a:off x="3394080" y="642240"/>
              <a:ext cx="942120" cy="1253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3" name="pole tekstowe 20"/>
            <p:cNvSpPr/>
            <p:nvPr/>
          </p:nvSpPr>
          <p:spPr>
            <a:xfrm>
              <a:off x="4114440" y="593640"/>
              <a:ext cx="381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1100" spc="-1" strike="noStrike">
                  <a:solidFill>
                    <a:srgbClr val="ffffff"/>
                  </a:solidFill>
                  <a:latin typeface="Arial"/>
                </a:rPr>
                <a:t>c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4" name="Grupa 21"/>
          <p:cNvGrpSpPr/>
          <p:nvPr/>
        </p:nvGrpSpPr>
        <p:grpSpPr>
          <a:xfrm>
            <a:off x="204840" y="2449440"/>
            <a:ext cx="1452600" cy="1298520"/>
            <a:chOff x="204840" y="2449440"/>
            <a:chExt cx="1452600" cy="1298520"/>
          </a:xfrm>
        </p:grpSpPr>
        <p:pic>
          <p:nvPicPr>
            <p:cNvPr id="55" name="Picture 13" descr="szalka"/>
            <p:cNvPicPr/>
            <p:nvPr/>
          </p:nvPicPr>
          <p:blipFill>
            <a:blip r:embed="rId2"/>
            <a:stretch/>
          </p:blipFill>
          <p:spPr>
            <a:xfrm>
              <a:off x="204840" y="2495160"/>
              <a:ext cx="1289160" cy="1252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6" name="pole tekstowe 21"/>
            <p:cNvSpPr/>
            <p:nvPr/>
          </p:nvSpPr>
          <p:spPr>
            <a:xfrm>
              <a:off x="1276560" y="2449440"/>
              <a:ext cx="3808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1100" spc="-1" strike="noStrike">
                  <a:solidFill>
                    <a:srgbClr val="ffffff"/>
                  </a:solidFill>
                  <a:latin typeface="Arial"/>
                </a:rPr>
                <a:t>a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7" name="Grupa 23"/>
          <p:cNvGrpSpPr/>
          <p:nvPr/>
        </p:nvGrpSpPr>
        <p:grpSpPr>
          <a:xfrm>
            <a:off x="2459160" y="1646280"/>
            <a:ext cx="695160" cy="2798640"/>
            <a:chOff x="2459160" y="1646280"/>
            <a:chExt cx="695160" cy="2798640"/>
          </a:xfrm>
        </p:grpSpPr>
        <p:pic>
          <p:nvPicPr>
            <p:cNvPr id="58" name="Obraz 11" descr="DSC01698.JPG"/>
            <p:cNvPicPr/>
            <p:nvPr/>
          </p:nvPicPr>
          <p:blipFill>
            <a:blip r:embed="rId3"/>
            <a:srcRect l="33543" t="2856" r="40525" b="7974"/>
            <a:stretch/>
          </p:blipFill>
          <p:spPr>
            <a:xfrm>
              <a:off x="2459160" y="1689120"/>
              <a:ext cx="533520" cy="2755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9" name="pole tekstowe 22"/>
            <p:cNvSpPr/>
            <p:nvPr/>
          </p:nvSpPr>
          <p:spPr>
            <a:xfrm>
              <a:off x="2773440" y="1646280"/>
              <a:ext cx="3808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1100" spc="-1" strike="noStrike">
                  <a:solidFill>
                    <a:srgbClr val="ffffff"/>
                  </a:solidFill>
                  <a:latin typeface="Arial"/>
                </a:rPr>
                <a:t>b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0" name="AutoShape 29"/>
          <p:cNvSpPr/>
          <p:nvPr/>
        </p:nvSpPr>
        <p:spPr>
          <a:xfrm flipH="1" rot="10800000">
            <a:off x="1651680" y="3051000"/>
            <a:ext cx="647640" cy="144720"/>
          </a:xfrm>
          <a:prstGeom prst="rightArrow">
            <a:avLst>
              <a:gd name="adj1" fmla="val 50000"/>
              <a:gd name="adj2" fmla="val 111878"/>
            </a:avLst>
          </a:prstGeom>
          <a:solidFill>
            <a:srgbClr val="40404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920" bIns="259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AutoShape 29"/>
          <p:cNvSpPr/>
          <p:nvPr/>
        </p:nvSpPr>
        <p:spPr>
          <a:xfrm flipH="1" rot="10800000">
            <a:off x="4013640" y="3019320"/>
            <a:ext cx="647640" cy="144720"/>
          </a:xfrm>
          <a:prstGeom prst="rightArrow">
            <a:avLst>
              <a:gd name="adj1" fmla="val 50000"/>
              <a:gd name="adj2" fmla="val 111878"/>
            </a:avLst>
          </a:prstGeom>
          <a:solidFill>
            <a:srgbClr val="40404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920" bIns="259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AutoShape 29"/>
          <p:cNvSpPr/>
          <p:nvPr/>
        </p:nvSpPr>
        <p:spPr>
          <a:xfrm flipH="1" rot="10800000">
            <a:off x="5999760" y="3019320"/>
            <a:ext cx="647640" cy="144720"/>
          </a:xfrm>
          <a:prstGeom prst="rightArrow">
            <a:avLst>
              <a:gd name="adj1" fmla="val 50000"/>
              <a:gd name="adj2" fmla="val 111878"/>
            </a:avLst>
          </a:prstGeom>
          <a:solidFill>
            <a:srgbClr val="40404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920" bIns="259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3" name="Grupa 27"/>
          <p:cNvGrpSpPr/>
          <p:nvPr/>
        </p:nvGrpSpPr>
        <p:grpSpPr>
          <a:xfrm>
            <a:off x="4792680" y="860400"/>
            <a:ext cx="1014480" cy="4390920"/>
            <a:chOff x="4792680" y="860400"/>
            <a:chExt cx="1014480" cy="4390920"/>
          </a:xfrm>
        </p:grpSpPr>
        <p:pic>
          <p:nvPicPr>
            <p:cNvPr id="64" name="Obraz 22" descr="DSC01747.JPG"/>
            <p:cNvPicPr/>
            <p:nvPr/>
          </p:nvPicPr>
          <p:blipFill>
            <a:blip r:embed="rId4">
              <a:lum bright="-20000"/>
            </a:blip>
            <a:srcRect l="3514" t="42391" r="4323" b="37113"/>
            <a:stretch/>
          </p:blipFill>
          <p:spPr>
            <a:xfrm rot="5400000">
              <a:off x="3088800" y="2565360"/>
              <a:ext cx="4389480" cy="982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5" name="pole tekstowe 23"/>
            <p:cNvSpPr/>
            <p:nvPr/>
          </p:nvSpPr>
          <p:spPr>
            <a:xfrm>
              <a:off x="5464800" y="860400"/>
              <a:ext cx="3423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1100" spc="-1" strike="noStrike">
                  <a:solidFill>
                    <a:srgbClr val="ffffff"/>
                  </a:solidFill>
                  <a:latin typeface="Arial"/>
                </a:rPr>
                <a:t>d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6" name="Grupa 24"/>
          <p:cNvGrpSpPr/>
          <p:nvPr/>
        </p:nvGrpSpPr>
        <p:grpSpPr>
          <a:xfrm>
            <a:off x="6759720" y="777960"/>
            <a:ext cx="1677960" cy="4757760"/>
            <a:chOff x="6759720" y="777960"/>
            <a:chExt cx="1677960" cy="4757760"/>
          </a:xfrm>
        </p:grpSpPr>
        <p:pic>
          <p:nvPicPr>
            <p:cNvPr id="67" name="Obraz 25" descr="DSC01740.JPG"/>
            <p:cNvPicPr/>
            <p:nvPr/>
          </p:nvPicPr>
          <p:blipFill>
            <a:blip r:embed="rId5">
              <a:lum bright="-10000"/>
            </a:blip>
            <a:srcRect l="4597" t="28380" r="9461" b="28585"/>
            <a:stretch/>
          </p:blipFill>
          <p:spPr>
            <a:xfrm rot="16200000">
              <a:off x="5173920" y="2363760"/>
              <a:ext cx="4757760" cy="1586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8" name="pole tekstowe 24"/>
            <p:cNvSpPr/>
            <p:nvPr/>
          </p:nvSpPr>
          <p:spPr>
            <a:xfrm>
              <a:off x="8056800" y="805680"/>
              <a:ext cx="3808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1100" spc="-1" strike="noStrike">
                  <a:solidFill>
                    <a:srgbClr val="ffffff"/>
                  </a:solidFill>
                  <a:latin typeface="Arial"/>
                </a:rPr>
                <a:t>e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9" name="Prostokąt 28"/>
          <p:cNvSpPr/>
          <p:nvPr/>
        </p:nvSpPr>
        <p:spPr>
          <a:xfrm>
            <a:off x="284040" y="5657760"/>
            <a:ext cx="8477280" cy="370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2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1-09T12:51:50Z</dcterms:created>
  <dc:creator>Beata</dc:creator>
  <dc:description/>
  <dc:language>en-US</dc:language>
  <cp:lastModifiedBy>Beata</cp:lastModifiedBy>
  <dcterms:modified xsi:type="dcterms:W3CDTF">2014-02-20T08:12:08Z</dcterms:modified>
  <cp:revision>40</cp:revision>
  <dc:subject/>
  <dc:title>Slajd 1</dc:title>
</cp:coreProperties>
</file>